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2" r:id="rId3"/>
    <p:sldId id="269" r:id="rId4"/>
    <p:sldId id="26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8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Volumes\fs_hmr_scifstor02$\Scleroderma\Chris\qPCR%20data\HOTAIR%20media%20plus%20GSK126%20Hacat%20cell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Volumes\shared\Faculty-of-Medicine-and-Health\LIRMM\Scleroderma\Chris\K9%20blot%20analysi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ifit1!$B$2:$X$2</c:f>
              <c:strCache>
                <c:ptCount val="23"/>
                <c:pt idx="0">
                  <c:v>ctr</c:v>
                </c:pt>
                <c:pt idx="1">
                  <c:v>ODN</c:v>
                </c:pt>
                <c:pt idx="2">
                  <c:v>ODN+28B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K9'!$B$15:$F$15</c:f>
                <c:numCache>
                  <c:formatCode>General</c:formatCode>
                  <c:ptCount val="5"/>
                  <c:pt idx="0">
                    <c:v>3.2001764320996399E-4</c:v>
                  </c:pt>
                  <c:pt idx="1">
                    <c:v>4.3806306301474401E-4</c:v>
                  </c:pt>
                  <c:pt idx="2">
                    <c:v>5.1913983264867999E-4</c:v>
                  </c:pt>
                </c:numCache>
              </c:numRef>
            </c:plus>
            <c:minus>
              <c:numRef>
                <c:f>'K9'!$B$15:$F$15</c:f>
                <c:numCache>
                  <c:formatCode>General</c:formatCode>
                  <c:ptCount val="5"/>
                  <c:pt idx="0">
                    <c:v>3.2001764320996399E-4</c:v>
                  </c:pt>
                  <c:pt idx="1">
                    <c:v>4.3806306301474401E-4</c:v>
                  </c:pt>
                  <c:pt idx="2">
                    <c:v>5.1913983264867999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K9'!$B$2:$D$2</c:f>
              <c:strCache>
                <c:ptCount val="3"/>
                <c:pt idx="0">
                  <c:v>Scramble</c:v>
                </c:pt>
                <c:pt idx="1">
                  <c:v>HOTAIR</c:v>
                </c:pt>
                <c:pt idx="2">
                  <c:v>HOTAIR GSK126</c:v>
                </c:pt>
              </c:strCache>
            </c:strRef>
          </c:cat>
          <c:val>
            <c:numRef>
              <c:f>'K9'!$B$13:$D$13</c:f>
              <c:numCache>
                <c:formatCode>General</c:formatCode>
                <c:ptCount val="3"/>
                <c:pt idx="0">
                  <c:v>2.1319106000000001E-3</c:v>
                </c:pt>
                <c:pt idx="1">
                  <c:v>3.9809664E-3</c:v>
                </c:pt>
                <c:pt idx="2">
                  <c:v>2.54625600000000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6E4-124C-B1DB-C89177E792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-1108630752"/>
        <c:axId val="-1108628432"/>
      </c:barChart>
      <c:catAx>
        <c:axId val="-1108630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08628432"/>
        <c:crosses val="autoZero"/>
        <c:auto val="1"/>
        <c:lblAlgn val="ctr"/>
        <c:lblOffset val="100"/>
        <c:noMultiLvlLbl val="0"/>
      </c:catAx>
      <c:valAx>
        <c:axId val="-110862843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086307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49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B$51:$E$51</c:f>
                <c:numCache>
                  <c:formatCode>General</c:formatCode>
                  <c:ptCount val="4"/>
                  <c:pt idx="0">
                    <c:v>1.7976822477828701E-4</c:v>
                  </c:pt>
                  <c:pt idx="1">
                    <c:v>3.1127687567255398E-4</c:v>
                  </c:pt>
                  <c:pt idx="2">
                    <c:v>6.5343611182722299E-5</c:v>
                  </c:pt>
                  <c:pt idx="3">
                    <c:v>1.22785243537532E-4</c:v>
                  </c:pt>
                </c:numCache>
              </c:numRef>
            </c:plus>
            <c:minus>
              <c:numRef>
                <c:f>Sheet2!$B$51:$E$51</c:f>
                <c:numCache>
                  <c:formatCode>General</c:formatCode>
                  <c:ptCount val="4"/>
                  <c:pt idx="0">
                    <c:v>1.7976822477828701E-4</c:v>
                  </c:pt>
                  <c:pt idx="1">
                    <c:v>3.1127687567255398E-4</c:v>
                  </c:pt>
                  <c:pt idx="2">
                    <c:v>6.5343611182722299E-5</c:v>
                  </c:pt>
                  <c:pt idx="3">
                    <c:v>1.22785243537532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48:$E$48</c:f>
              <c:strCache>
                <c:ptCount val="4"/>
                <c:pt idx="0">
                  <c:v>Healthy</c:v>
                </c:pt>
                <c:pt idx="1">
                  <c:v>Healthy AQB</c:v>
                </c:pt>
                <c:pt idx="2">
                  <c:v>SSc</c:v>
                </c:pt>
                <c:pt idx="3">
                  <c:v>SSc AQB</c:v>
                </c:pt>
              </c:strCache>
            </c:strRef>
          </c:cat>
          <c:val>
            <c:numRef>
              <c:f>Sheet2!$B$49:$E$49</c:f>
              <c:numCache>
                <c:formatCode>General</c:formatCode>
                <c:ptCount val="4"/>
                <c:pt idx="0">
                  <c:v>6.8222305791822298E-4</c:v>
                </c:pt>
                <c:pt idx="1">
                  <c:v>1.1275927828856701E-3</c:v>
                </c:pt>
                <c:pt idx="2">
                  <c:v>1.1073347297827401E-3</c:v>
                </c:pt>
                <c:pt idx="3">
                  <c:v>5.667623935061730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997-4FE7-9319-EDDD95CAE4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-1107556320"/>
        <c:axId val="-1107554000"/>
      </c:barChart>
      <c:catAx>
        <c:axId val="-1107556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07554000"/>
        <c:crosses val="autoZero"/>
        <c:auto val="1"/>
        <c:lblAlgn val="ctr"/>
        <c:lblOffset val="100"/>
        <c:noMultiLvlLbl val="0"/>
      </c:catAx>
      <c:valAx>
        <c:axId val="-1107554000"/>
        <c:scaling>
          <c:orientation val="minMax"/>
        </c:scaling>
        <c:delete val="0"/>
        <c:axPos val="l"/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075563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P$9</c:f>
              <c:strCache>
                <c:ptCount val="1"/>
                <c:pt idx="0">
                  <c:v>Twis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Q$11:$T$11</c:f>
                <c:numCache>
                  <c:formatCode>General</c:formatCode>
                  <c:ptCount val="4"/>
                  <c:pt idx="0">
                    <c:v>2.90549092267629E-4</c:v>
                  </c:pt>
                  <c:pt idx="1">
                    <c:v>7.2091287674797499E-4</c:v>
                  </c:pt>
                  <c:pt idx="2">
                    <c:v>1.86180296846116E-4</c:v>
                  </c:pt>
                  <c:pt idx="3">
                    <c:v>0</c:v>
                  </c:pt>
                </c:numCache>
              </c:numRef>
            </c:plus>
            <c:minus>
              <c:numRef>
                <c:f>Sheet2!$Q$11:$T$11</c:f>
                <c:numCache>
                  <c:formatCode>General</c:formatCode>
                  <c:ptCount val="4"/>
                  <c:pt idx="0">
                    <c:v>2.90549092267629E-4</c:v>
                  </c:pt>
                  <c:pt idx="1">
                    <c:v>7.2091287674797499E-4</c:v>
                  </c:pt>
                  <c:pt idx="2">
                    <c:v>1.86180296846116E-4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Q$8:$T$8</c:f>
              <c:strCache>
                <c:ptCount val="4"/>
                <c:pt idx="0">
                  <c:v>Healthy</c:v>
                </c:pt>
                <c:pt idx="1">
                  <c:v>Healthy AQB</c:v>
                </c:pt>
                <c:pt idx="2">
                  <c:v>SSc</c:v>
                </c:pt>
                <c:pt idx="3">
                  <c:v>SSc AQB</c:v>
                </c:pt>
              </c:strCache>
            </c:strRef>
          </c:cat>
          <c:val>
            <c:numRef>
              <c:f>Sheet2!$Q$9:$T$9</c:f>
              <c:numCache>
                <c:formatCode>General</c:formatCode>
                <c:ptCount val="4"/>
                <c:pt idx="0">
                  <c:v>3.9284244366752499E-4</c:v>
                </c:pt>
                <c:pt idx="1">
                  <c:v>8.0089294290143899E-4</c:v>
                </c:pt>
                <c:pt idx="2">
                  <c:v>1.12947749306178E-3</c:v>
                </c:pt>
                <c:pt idx="3">
                  <c:v>3.9386804649517898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4C-42A9-81D8-CCE680C113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-1108673616"/>
        <c:axId val="-1108671296"/>
      </c:barChart>
      <c:catAx>
        <c:axId val="-1108673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08671296"/>
        <c:crosses val="autoZero"/>
        <c:auto val="1"/>
        <c:lblAlgn val="ctr"/>
        <c:lblOffset val="100"/>
        <c:noMultiLvlLbl val="0"/>
      </c:catAx>
      <c:valAx>
        <c:axId val="-110867129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086736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549 SSc fibro AQB'!$J$11</c:f>
              <c:strCache>
                <c:ptCount val="1"/>
                <c:pt idx="0">
                  <c:v>N CAD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549 SSc fibro AQB'!$K$13:$N$13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28175335640937</c:v>
                  </c:pt>
                  <c:pt idx="2">
                    <c:v>8.9514994088513405E-2</c:v>
                  </c:pt>
                  <c:pt idx="3">
                    <c:v>9.0611234586741002E-2</c:v>
                  </c:pt>
                </c:numCache>
              </c:numRef>
            </c:plus>
            <c:minus>
              <c:numRef>
                <c:f>'A549 SSc fibro AQB'!$K$13:$N$13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28175335640937</c:v>
                  </c:pt>
                  <c:pt idx="2">
                    <c:v>8.9514994088513405E-2</c:v>
                  </c:pt>
                  <c:pt idx="3">
                    <c:v>9.06112345867410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549 SSc fibro AQB'!$K$10:$N$10</c:f>
              <c:strCache>
                <c:ptCount val="4"/>
                <c:pt idx="0">
                  <c:v>Healthy </c:v>
                </c:pt>
                <c:pt idx="1">
                  <c:v>Healthy AQB</c:v>
                </c:pt>
                <c:pt idx="2">
                  <c:v>SSc</c:v>
                </c:pt>
                <c:pt idx="3">
                  <c:v>SSc AQB</c:v>
                </c:pt>
              </c:strCache>
            </c:strRef>
          </c:cat>
          <c:val>
            <c:numRef>
              <c:f>'A549 SSc fibro AQB'!$K$11:$N$11</c:f>
              <c:numCache>
                <c:formatCode>General</c:formatCode>
                <c:ptCount val="4"/>
                <c:pt idx="0">
                  <c:v>1</c:v>
                </c:pt>
                <c:pt idx="1">
                  <c:v>1.1074999999999999</c:v>
                </c:pt>
                <c:pt idx="2">
                  <c:v>1.36765</c:v>
                </c:pt>
                <c:pt idx="3">
                  <c:v>1.005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A99-4325-964D-7138083664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-1108202768"/>
        <c:axId val="-1109334032"/>
      </c:barChart>
      <c:catAx>
        <c:axId val="-1108202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09334032"/>
        <c:crosses val="autoZero"/>
        <c:auto val="1"/>
        <c:lblAlgn val="ctr"/>
        <c:lblOffset val="100"/>
        <c:noMultiLvlLbl val="0"/>
      </c:catAx>
      <c:valAx>
        <c:axId val="-110933403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08202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606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497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700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687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26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120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413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839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018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626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190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04589A-D0AA-454F-A10B-37F01468BA25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F2D27E-71AC-3B45-8778-BBBFB522DD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864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2.tiff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tiff"/><Relationship Id="rId4" Type="http://schemas.openxmlformats.org/officeDocument/2006/relationships/image" Target="../media/image3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13" Type="http://schemas.microsoft.com/office/2007/relationships/hdphoto" Target="../media/hdphoto5.wdp"/><Relationship Id="rId3" Type="http://schemas.openxmlformats.org/officeDocument/2006/relationships/image" Target="../media/image9.png"/><Relationship Id="rId7" Type="http://schemas.microsoft.com/office/2007/relationships/hdphoto" Target="../media/hdphoto3.wdp"/><Relationship Id="rId12" Type="http://schemas.openxmlformats.org/officeDocument/2006/relationships/image" Target="../media/image14.jpeg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11" Type="http://schemas.openxmlformats.org/officeDocument/2006/relationships/chart" Target="../charts/chart4.xml"/><Relationship Id="rId5" Type="http://schemas.openxmlformats.org/officeDocument/2006/relationships/image" Target="../media/image10.tiff"/><Relationship Id="rId10" Type="http://schemas.microsoft.com/office/2007/relationships/hdphoto" Target="../media/hdphoto4.wdp"/><Relationship Id="rId4" Type="http://schemas.microsoft.com/office/2007/relationships/hdphoto" Target="../media/hdphoto2.wdp"/><Relationship Id="rId9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3A665CB-C9E9-7940-B554-2AF6B1840D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5866" y="4251308"/>
            <a:ext cx="2019866" cy="237712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D2F2815-710E-D647-BB8B-DB678ED75F4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duotone>
              <a:prstClr val="black"/>
              <a:schemeClr val="accent3">
                <a:tint val="45000"/>
                <a:satMod val="400000"/>
              </a:schemeClr>
            </a:duotone>
          </a:blip>
          <a:srcRect r="811"/>
          <a:stretch/>
        </p:blipFill>
        <p:spPr>
          <a:xfrm>
            <a:off x="5978759" y="5364407"/>
            <a:ext cx="1431573" cy="5419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D7851FF-338E-C240-B5F5-B78890F36089}"/>
              </a:ext>
            </a:extLst>
          </p:cNvPr>
          <p:cNvSpPr txBox="1"/>
          <p:nvPr/>
        </p:nvSpPr>
        <p:spPr>
          <a:xfrm>
            <a:off x="7410332" y="5541887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β-act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90D15CA-66C8-AC45-B360-72BE675CCFF1}"/>
              </a:ext>
            </a:extLst>
          </p:cNvPr>
          <p:cNvSpPr txBox="1"/>
          <p:nvPr/>
        </p:nvSpPr>
        <p:spPr>
          <a:xfrm>
            <a:off x="7431499" y="3972404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GSK12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C37339A-1386-AB4A-BB43-F035C7A0CFC8}"/>
              </a:ext>
            </a:extLst>
          </p:cNvPr>
          <p:cNvSpPr txBox="1"/>
          <p:nvPr/>
        </p:nvSpPr>
        <p:spPr>
          <a:xfrm>
            <a:off x="7431499" y="4254929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SSc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FD43CAF-D89E-8040-BD7A-9BCF80475298}"/>
              </a:ext>
            </a:extLst>
          </p:cNvPr>
          <p:cNvSpPr txBox="1"/>
          <p:nvPr/>
        </p:nvSpPr>
        <p:spPr>
          <a:xfrm>
            <a:off x="7431499" y="4506927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Healthy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62240D2-5763-7E46-BD9F-1E73EC36BE51}"/>
              </a:ext>
            </a:extLst>
          </p:cNvPr>
          <p:cNvSpPr txBox="1"/>
          <p:nvPr/>
        </p:nvSpPr>
        <p:spPr>
          <a:xfrm>
            <a:off x="7396634" y="4857644"/>
            <a:ext cx="7986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Keratin 9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11A9CEF-B820-6243-86AB-687C4ED36AC7}"/>
              </a:ext>
            </a:extLst>
          </p:cNvPr>
          <p:cNvSpPr txBox="1"/>
          <p:nvPr/>
        </p:nvSpPr>
        <p:spPr>
          <a:xfrm>
            <a:off x="6532170" y="414005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69F985B-9CD8-5941-9F71-DF98BD9A3EA8}"/>
              </a:ext>
            </a:extLst>
          </p:cNvPr>
          <p:cNvSpPr txBox="1"/>
          <p:nvPr/>
        </p:nvSpPr>
        <p:spPr>
          <a:xfrm>
            <a:off x="6066053" y="440385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4B0D4D8-410C-EF4E-9C15-1A0E44CCE898}"/>
              </a:ext>
            </a:extLst>
          </p:cNvPr>
          <p:cNvSpPr txBox="1"/>
          <p:nvPr/>
        </p:nvSpPr>
        <p:spPr>
          <a:xfrm>
            <a:off x="6981831" y="414293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663B3C7-106D-AF45-A3AE-4294BF3ADE8B}"/>
              </a:ext>
            </a:extLst>
          </p:cNvPr>
          <p:cNvSpPr txBox="1"/>
          <p:nvPr/>
        </p:nvSpPr>
        <p:spPr>
          <a:xfrm>
            <a:off x="6981831" y="387930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31CDD123-4E4A-854B-949A-AC53CCB33B8B}"/>
              </a:ext>
            </a:extLst>
          </p:cNvPr>
          <p:cNvCxnSpPr/>
          <p:nvPr/>
        </p:nvCxnSpPr>
        <p:spPr>
          <a:xfrm>
            <a:off x="5798126" y="5075231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296939E3-FAD5-854C-8D49-3F0AE6968B7D}"/>
              </a:ext>
            </a:extLst>
          </p:cNvPr>
          <p:cNvSpPr txBox="1"/>
          <p:nvPr/>
        </p:nvSpPr>
        <p:spPr>
          <a:xfrm>
            <a:off x="5542475" y="448071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A884602-2F82-7445-BA8D-ECF98E8DFCB5}"/>
              </a:ext>
            </a:extLst>
          </p:cNvPr>
          <p:cNvSpPr txBox="1"/>
          <p:nvPr/>
        </p:nvSpPr>
        <p:spPr>
          <a:xfrm>
            <a:off x="5500114" y="49420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5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60E36D5-9D96-F549-A59D-C3831CFD09BA}"/>
              </a:ext>
            </a:extLst>
          </p:cNvPr>
          <p:cNvSpPr txBox="1"/>
          <p:nvPr/>
        </p:nvSpPr>
        <p:spPr>
          <a:xfrm>
            <a:off x="5500114" y="542018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46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DA66B80-94BD-BB40-882B-2DB08B07C801}"/>
              </a:ext>
            </a:extLst>
          </p:cNvPr>
          <p:cNvCxnSpPr/>
          <p:nvPr/>
        </p:nvCxnSpPr>
        <p:spPr>
          <a:xfrm>
            <a:off x="5798126" y="5558684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C2AEDC7A-0051-3846-B83D-5E98BF8F308E}"/>
              </a:ext>
            </a:extLst>
          </p:cNvPr>
          <p:cNvSpPr txBox="1"/>
          <p:nvPr/>
        </p:nvSpPr>
        <p:spPr>
          <a:xfrm>
            <a:off x="6539485" y="440444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94D12D3-552E-944E-8D73-4EFB4733D22A}"/>
              </a:ext>
            </a:extLst>
          </p:cNvPr>
          <p:cNvSpPr txBox="1"/>
          <p:nvPr/>
        </p:nvSpPr>
        <p:spPr>
          <a:xfrm>
            <a:off x="7004752" y="4404479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3DBD6D6-82DF-B040-9B09-B7DF65B31BC3}"/>
              </a:ext>
            </a:extLst>
          </p:cNvPr>
          <p:cNvSpPr txBox="1"/>
          <p:nvPr/>
        </p:nvSpPr>
        <p:spPr>
          <a:xfrm>
            <a:off x="6091017" y="4132103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185FFB2-ABA5-6848-8C1F-EA2BB2A61624}"/>
              </a:ext>
            </a:extLst>
          </p:cNvPr>
          <p:cNvSpPr txBox="1"/>
          <p:nvPr/>
        </p:nvSpPr>
        <p:spPr>
          <a:xfrm>
            <a:off x="6539485" y="389316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130F8B1-794E-7940-A0E2-2DD9C88EECA4}"/>
              </a:ext>
            </a:extLst>
          </p:cNvPr>
          <p:cNvSpPr txBox="1"/>
          <p:nvPr/>
        </p:nvSpPr>
        <p:spPr>
          <a:xfrm>
            <a:off x="6091017" y="389316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7C17ED82-9F58-9449-8026-7FE70F16DD7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34000" contrast="54000"/>
                    </a14:imgEffect>
                  </a14:imgLayer>
                </a14:imgProps>
              </a:ext>
            </a:extLst>
          </a:blip>
          <a:srcRect t="9023" b="14646"/>
          <a:stretch/>
        </p:blipFill>
        <p:spPr>
          <a:xfrm>
            <a:off x="5981093" y="4764040"/>
            <a:ext cx="1429239" cy="5475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A37E2E7E-35BE-C748-A607-82A73B7E34E4}"/>
              </a:ext>
            </a:extLst>
          </p:cNvPr>
          <p:cNvSpPr txBox="1"/>
          <p:nvPr/>
        </p:nvSpPr>
        <p:spPr>
          <a:xfrm>
            <a:off x="3582587" y="3965588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58CBF9E-306D-C340-8FE0-1EE1A8D84711}"/>
              </a:ext>
            </a:extLst>
          </p:cNvPr>
          <p:cNvSpPr txBox="1"/>
          <p:nvPr/>
        </p:nvSpPr>
        <p:spPr>
          <a:xfrm>
            <a:off x="5245879" y="3973113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BC5A335E-F4BB-D946-A4ED-B5A362DBD257}"/>
              </a:ext>
            </a:extLst>
          </p:cNvPr>
          <p:cNvPicPr>
            <a:picLocks noChangeAspect="1"/>
          </p:cNvPicPr>
          <p:nvPr/>
        </p:nvPicPr>
        <p:blipFill>
          <a:blip r:embed="rId5">
            <a:duotone>
              <a:prstClr val="black"/>
              <a:schemeClr val="accent3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 rot="5400000">
            <a:off x="5447732" y="2157641"/>
            <a:ext cx="550528" cy="144327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C19EA535-45CC-9C46-91F4-3F32ECFD7C9F}"/>
              </a:ext>
            </a:extLst>
          </p:cNvPr>
          <p:cNvSpPr txBox="1"/>
          <p:nvPr/>
        </p:nvSpPr>
        <p:spPr>
          <a:xfrm>
            <a:off x="6435998" y="2723980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β-actin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633797E-1F4F-5B48-A576-8213A6B554D1}"/>
              </a:ext>
            </a:extLst>
          </p:cNvPr>
          <p:cNvSpPr txBox="1"/>
          <p:nvPr/>
        </p:nvSpPr>
        <p:spPr>
          <a:xfrm>
            <a:off x="6475592" y="1227186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GSK126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9A15B49-0DBB-434A-98A8-9503F2AB2BD1}"/>
              </a:ext>
            </a:extLst>
          </p:cNvPr>
          <p:cNvSpPr txBox="1"/>
          <p:nvPr/>
        </p:nvSpPr>
        <p:spPr>
          <a:xfrm>
            <a:off x="6475592" y="1509711"/>
            <a:ext cx="755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HOTAIR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340793E-7339-194F-A6EC-EA586A48CE53}"/>
              </a:ext>
            </a:extLst>
          </p:cNvPr>
          <p:cNvSpPr txBox="1"/>
          <p:nvPr/>
        </p:nvSpPr>
        <p:spPr>
          <a:xfrm>
            <a:off x="6475592" y="1761709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Scrambl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915E4CB-45BD-7242-889D-A4E592AAFBCA}"/>
              </a:ext>
            </a:extLst>
          </p:cNvPr>
          <p:cNvSpPr txBox="1"/>
          <p:nvPr/>
        </p:nvSpPr>
        <p:spPr>
          <a:xfrm>
            <a:off x="6440727" y="2112426"/>
            <a:ext cx="7986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Keratin 9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B8CE9A2-94B9-334D-9DDB-E40EF6B60A07}"/>
              </a:ext>
            </a:extLst>
          </p:cNvPr>
          <p:cNvSpPr txBox="1"/>
          <p:nvPr/>
        </p:nvSpPr>
        <p:spPr>
          <a:xfrm>
            <a:off x="5576263" y="139484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A553BCE-1DEE-9349-849C-B4F4EAD9C70E}"/>
              </a:ext>
            </a:extLst>
          </p:cNvPr>
          <p:cNvSpPr txBox="1"/>
          <p:nvPr/>
        </p:nvSpPr>
        <p:spPr>
          <a:xfrm>
            <a:off x="5110146" y="165863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88907EC-64F3-0F42-905D-33BF4D9DF106}"/>
              </a:ext>
            </a:extLst>
          </p:cNvPr>
          <p:cNvSpPr txBox="1"/>
          <p:nvPr/>
        </p:nvSpPr>
        <p:spPr>
          <a:xfrm>
            <a:off x="6025924" y="139772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8A55A45-2101-B34F-B765-E9B59467E9BB}"/>
              </a:ext>
            </a:extLst>
          </p:cNvPr>
          <p:cNvSpPr txBox="1"/>
          <p:nvPr/>
        </p:nvSpPr>
        <p:spPr>
          <a:xfrm>
            <a:off x="6020760" y="113380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C5234352-1AE3-6546-8B0A-4D673ABBB9DE}"/>
              </a:ext>
            </a:extLst>
          </p:cNvPr>
          <p:cNvCxnSpPr/>
          <p:nvPr/>
        </p:nvCxnSpPr>
        <p:spPr>
          <a:xfrm>
            <a:off x="4832782" y="2296779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A58F2C7E-4872-DD40-849D-0E2D161FBA0B}"/>
              </a:ext>
            </a:extLst>
          </p:cNvPr>
          <p:cNvSpPr txBox="1"/>
          <p:nvPr/>
        </p:nvSpPr>
        <p:spPr>
          <a:xfrm>
            <a:off x="4586568" y="1735499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kDa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8C77147-4494-3748-B5C8-5B24700F88C2}"/>
              </a:ext>
            </a:extLst>
          </p:cNvPr>
          <p:cNvSpPr txBox="1"/>
          <p:nvPr/>
        </p:nvSpPr>
        <p:spPr>
          <a:xfrm>
            <a:off x="4536991" y="215993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5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FB92E61-F24E-4943-983E-49F7BDE000F6}"/>
              </a:ext>
            </a:extLst>
          </p:cNvPr>
          <p:cNvSpPr txBox="1"/>
          <p:nvPr/>
        </p:nvSpPr>
        <p:spPr>
          <a:xfrm>
            <a:off x="4525780" y="26022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46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9D473080-6247-AC4E-B9F5-77B706E12518}"/>
              </a:ext>
            </a:extLst>
          </p:cNvPr>
          <p:cNvCxnSpPr/>
          <p:nvPr/>
        </p:nvCxnSpPr>
        <p:spPr>
          <a:xfrm>
            <a:off x="4823792" y="2740777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5" name="Picture 54">
            <a:extLst>
              <a:ext uri="{FF2B5EF4-FFF2-40B4-BE49-F238E27FC236}">
                <a16:creationId xmlns:a16="http://schemas.microsoft.com/office/drawing/2014/main" id="{AB0F8DB4-6E1C-FB4C-A6F4-20EF1DFB30E3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001361" y="1995054"/>
            <a:ext cx="1427128" cy="5560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B04000DD-24FA-634B-AC23-855CA86CE96B}"/>
              </a:ext>
            </a:extLst>
          </p:cNvPr>
          <p:cNvSpPr txBox="1"/>
          <p:nvPr/>
        </p:nvSpPr>
        <p:spPr>
          <a:xfrm rot="16200000">
            <a:off x="6828641" y="2412931"/>
            <a:ext cx="176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eratin 9 transcript levels</a:t>
            </a:r>
          </a:p>
        </p:txBody>
      </p:sp>
      <p:graphicFrame>
        <p:nvGraphicFramePr>
          <p:cNvPr id="57" name="Chart 56">
            <a:extLst>
              <a:ext uri="{FF2B5EF4-FFF2-40B4-BE49-F238E27FC236}">
                <a16:creationId xmlns:a16="http://schemas.microsoft.com/office/drawing/2014/main" id="{08391451-58E5-C047-B4EB-ED3B6E5FDF96}"/>
              </a:ext>
            </a:extLst>
          </p:cNvPr>
          <p:cNvGraphicFramePr>
            <a:graphicFrameLocks/>
          </p:cNvGraphicFramePr>
          <p:nvPr/>
        </p:nvGraphicFramePr>
        <p:xfrm>
          <a:off x="7763120" y="1959623"/>
          <a:ext cx="1942190" cy="1517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39FAB411-9AD3-EC4C-A2AD-9EF48820EB49}"/>
              </a:ext>
            </a:extLst>
          </p:cNvPr>
          <p:cNvCxnSpPr/>
          <p:nvPr/>
        </p:nvCxnSpPr>
        <p:spPr>
          <a:xfrm flipV="1">
            <a:off x="8918088" y="2054144"/>
            <a:ext cx="45458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560A699A-35CD-FA42-A441-01EDB865723C}"/>
              </a:ext>
            </a:extLst>
          </p:cNvPr>
          <p:cNvCxnSpPr/>
          <p:nvPr/>
        </p:nvCxnSpPr>
        <p:spPr>
          <a:xfrm>
            <a:off x="8391744" y="2054145"/>
            <a:ext cx="425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A3611ACB-C581-8749-AD66-7B07D03B121E}"/>
              </a:ext>
            </a:extLst>
          </p:cNvPr>
          <p:cNvSpPr txBox="1"/>
          <p:nvPr/>
        </p:nvSpPr>
        <p:spPr>
          <a:xfrm>
            <a:off x="8479846" y="184136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5554CD9-7147-364C-B665-8D6B2A8C7750}"/>
              </a:ext>
            </a:extLst>
          </p:cNvPr>
          <p:cNvSpPr txBox="1"/>
          <p:nvPr/>
        </p:nvSpPr>
        <p:spPr>
          <a:xfrm>
            <a:off x="9035050" y="182957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</a:t>
            </a:r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41759A6B-BB35-FB4B-A18C-5E0B8352022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6690" y="1124891"/>
            <a:ext cx="1927552" cy="2268479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1D49082A-E204-BC43-B4B0-4469F65BE361}"/>
              </a:ext>
            </a:extLst>
          </p:cNvPr>
          <p:cNvSpPr txBox="1"/>
          <p:nvPr/>
        </p:nvSpPr>
        <p:spPr>
          <a:xfrm>
            <a:off x="5583578" y="1659227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9722938-BB03-CC4E-8830-448D2DF4C384}"/>
              </a:ext>
            </a:extLst>
          </p:cNvPr>
          <p:cNvSpPr txBox="1"/>
          <p:nvPr/>
        </p:nvSpPr>
        <p:spPr>
          <a:xfrm>
            <a:off x="6033079" y="1659261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7680E0A-4BA5-884F-964A-3DDA33D28886}"/>
              </a:ext>
            </a:extLst>
          </p:cNvPr>
          <p:cNvSpPr txBox="1"/>
          <p:nvPr/>
        </p:nvSpPr>
        <p:spPr>
          <a:xfrm>
            <a:off x="5135110" y="138688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15BF727-E826-394E-9508-D1EC83BB8A93}"/>
              </a:ext>
            </a:extLst>
          </p:cNvPr>
          <p:cNvSpPr txBox="1"/>
          <p:nvPr/>
        </p:nvSpPr>
        <p:spPr>
          <a:xfrm>
            <a:off x="5583578" y="1147947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68B54FFF-9F50-694E-989D-8C52B629E34C}"/>
              </a:ext>
            </a:extLst>
          </p:cNvPr>
          <p:cNvSpPr txBox="1"/>
          <p:nvPr/>
        </p:nvSpPr>
        <p:spPr>
          <a:xfrm>
            <a:off x="5135110" y="1147947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0B279A1-1AE5-DA4D-BB87-7CE67E4EE43F}"/>
              </a:ext>
            </a:extLst>
          </p:cNvPr>
          <p:cNvSpPr txBox="1"/>
          <p:nvPr/>
        </p:nvSpPr>
        <p:spPr>
          <a:xfrm>
            <a:off x="1973409" y="98055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4671690-E66A-7A4B-8A01-135CCBF296FF}"/>
              </a:ext>
            </a:extLst>
          </p:cNvPr>
          <p:cNvSpPr txBox="1"/>
          <p:nvPr/>
        </p:nvSpPr>
        <p:spPr>
          <a:xfrm>
            <a:off x="4465648" y="102429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59D313B-93D5-DD4D-A0C1-FD7AF63B11A6}"/>
              </a:ext>
            </a:extLst>
          </p:cNvPr>
          <p:cNvSpPr txBox="1"/>
          <p:nvPr/>
        </p:nvSpPr>
        <p:spPr>
          <a:xfrm>
            <a:off x="7637112" y="104232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579349" y="315310"/>
            <a:ext cx="89586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1: HOTAIR induces keratin 9 in keratinocytes through the PRC2 complex</a:t>
            </a:r>
          </a:p>
        </p:txBody>
      </p:sp>
    </p:spTree>
    <p:extLst>
      <p:ext uri="{BB962C8B-B14F-4D97-AF65-F5344CB8AC3E}">
        <p14:creationId xmlns:p14="http://schemas.microsoft.com/office/powerpoint/2010/main" val="13041865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accent3">
                <a:tint val="45000"/>
                <a:satMod val="400000"/>
              </a:schemeClr>
            </a:duotone>
          </a:blip>
          <a:srcRect l="10028" r="7148"/>
          <a:stretch/>
        </p:blipFill>
        <p:spPr>
          <a:xfrm rot="5400000">
            <a:off x="4982452" y="1996557"/>
            <a:ext cx="553034" cy="14288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5958798" y="3161582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β-acti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958798" y="1534939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GSK126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973395" y="1863588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SSc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973395" y="2167592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Healthy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973395" y="2523184"/>
            <a:ext cx="817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β-cateni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081135" y="180379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665354" y="20521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572909" y="179826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572909" y="147714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cxnSp>
        <p:nvCxnSpPr>
          <p:cNvPr id="14" name="Straight Connector 13"/>
          <p:cNvCxnSpPr/>
          <p:nvPr/>
        </p:nvCxnSpPr>
        <p:spPr>
          <a:xfrm>
            <a:off x="4381795" y="2611819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4037382" y="2167593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kD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026433" y="246310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068861" y="302308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46</a:t>
            </a:r>
          </a:p>
        </p:txBody>
      </p:sp>
      <p:cxnSp>
        <p:nvCxnSpPr>
          <p:cNvPr id="18" name="Straight Connector 17"/>
          <p:cNvCxnSpPr/>
          <p:nvPr/>
        </p:nvCxnSpPr>
        <p:spPr>
          <a:xfrm>
            <a:off x="4366873" y="3161582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/>
          <p:cNvPicPr>
            <a:picLocks noChangeAspect="1"/>
          </p:cNvPicPr>
          <p:nvPr/>
        </p:nvPicPr>
        <p:blipFill>
          <a:blip r:embed="rId3">
            <a:duotone>
              <a:prstClr val="black"/>
              <a:schemeClr val="accent3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 rot="5400000">
            <a:off x="4982454" y="2612526"/>
            <a:ext cx="553034" cy="14288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BB6E7759-70B5-154F-B42A-49E794AE6450}"/>
              </a:ext>
            </a:extLst>
          </p:cNvPr>
          <p:cNvSpPr txBox="1"/>
          <p:nvPr/>
        </p:nvSpPr>
        <p:spPr>
          <a:xfrm>
            <a:off x="4699352" y="1468322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92440D3-C786-764D-BF0E-205497F26BAD}"/>
              </a:ext>
            </a:extLst>
          </p:cNvPr>
          <p:cNvSpPr txBox="1"/>
          <p:nvPr/>
        </p:nvSpPr>
        <p:spPr>
          <a:xfrm>
            <a:off x="5105961" y="1471164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D9E18DD-093B-0946-9172-C4DFB4D2E1B4}"/>
              </a:ext>
            </a:extLst>
          </p:cNvPr>
          <p:cNvSpPr txBox="1"/>
          <p:nvPr/>
        </p:nvSpPr>
        <p:spPr>
          <a:xfrm>
            <a:off x="4692950" y="179364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950BF4F-F76F-5641-A8FF-713D89AD0491}"/>
              </a:ext>
            </a:extLst>
          </p:cNvPr>
          <p:cNvSpPr txBox="1"/>
          <p:nvPr/>
        </p:nvSpPr>
        <p:spPr>
          <a:xfrm>
            <a:off x="5595351" y="2062821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AB65D05-4C33-9649-B285-8C6CEE0E64F4}"/>
              </a:ext>
            </a:extLst>
          </p:cNvPr>
          <p:cNvSpPr txBox="1"/>
          <p:nvPr/>
        </p:nvSpPr>
        <p:spPr>
          <a:xfrm>
            <a:off x="5109102" y="2078444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369684" y="57608"/>
            <a:ext cx="834440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2: HOTAIR regulates Wnt3a/β-Catenin signalling in Keratinocytes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rough its ability to modulate the PRC2 complex </a:t>
            </a:r>
          </a:p>
        </p:txBody>
      </p:sp>
    </p:spTree>
    <p:extLst>
      <p:ext uri="{BB962C8B-B14F-4D97-AF65-F5344CB8AC3E}">
        <p14:creationId xmlns:p14="http://schemas.microsoft.com/office/powerpoint/2010/main" val="15497926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6F157B44-D23B-D7DC-F0AA-AB06026AC178}"/>
              </a:ext>
            </a:extLst>
          </p:cNvPr>
          <p:cNvGraphicFramePr>
            <a:graphicFrameLocks/>
          </p:cNvGraphicFramePr>
          <p:nvPr/>
        </p:nvGraphicFramePr>
        <p:xfrm>
          <a:off x="6228673" y="1478298"/>
          <a:ext cx="2566939" cy="16895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A7558A8D-51F1-8B53-38DB-5A91F0E8D701}"/>
              </a:ext>
            </a:extLst>
          </p:cNvPr>
          <p:cNvGraphicFramePr>
            <a:graphicFrameLocks/>
          </p:cNvGraphicFramePr>
          <p:nvPr/>
        </p:nvGraphicFramePr>
        <p:xfrm>
          <a:off x="3123636" y="1446761"/>
          <a:ext cx="2545675" cy="16784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4ADAD8FB-D5C6-7240-BA92-D42F2D921214}"/>
              </a:ext>
            </a:extLst>
          </p:cNvPr>
          <p:cNvSpPr txBox="1"/>
          <p:nvPr/>
        </p:nvSpPr>
        <p:spPr>
          <a:xfrm rot="16200000">
            <a:off x="5360918" y="1945908"/>
            <a:ext cx="1537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NAIL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mRNA level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078E385-89EA-8F80-007E-5DEBCDD0117B}"/>
              </a:ext>
            </a:extLst>
          </p:cNvPr>
          <p:cNvSpPr txBox="1"/>
          <p:nvPr/>
        </p:nvSpPr>
        <p:spPr>
          <a:xfrm rot="16200000">
            <a:off x="2241933" y="1961151"/>
            <a:ext cx="1537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WIST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mRNA level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5126D00-A4FA-825B-79F8-640589DD368B}"/>
              </a:ext>
            </a:extLst>
          </p:cNvPr>
          <p:cNvSpPr txBox="1"/>
          <p:nvPr/>
        </p:nvSpPr>
        <p:spPr>
          <a:xfrm>
            <a:off x="5913664" y="107504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D314357-517E-8A12-69BE-A2AF82D27235}"/>
              </a:ext>
            </a:extLst>
          </p:cNvPr>
          <p:cNvSpPr txBox="1"/>
          <p:nvPr/>
        </p:nvSpPr>
        <p:spPr>
          <a:xfrm>
            <a:off x="2693093" y="101091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D310304-B694-06BC-4596-7B1240E70BCB}"/>
              </a:ext>
            </a:extLst>
          </p:cNvPr>
          <p:cNvSpPr txBox="1"/>
          <p:nvPr/>
        </p:nvSpPr>
        <p:spPr>
          <a:xfrm>
            <a:off x="1784271" y="323185"/>
            <a:ext cx="7478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3: HOTAIR induces and EMT expression in keratinocytes</a:t>
            </a:r>
          </a:p>
        </p:txBody>
      </p:sp>
    </p:spTree>
    <p:extLst>
      <p:ext uri="{BB962C8B-B14F-4D97-AF65-F5344CB8AC3E}">
        <p14:creationId xmlns:p14="http://schemas.microsoft.com/office/powerpoint/2010/main" val="22830840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20515" y="985688"/>
            <a:ext cx="6644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althy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725759" y="997549"/>
            <a:ext cx="3914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Sc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263941" y="1294191"/>
            <a:ext cx="9620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QB (20µM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271894" y="1538745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MSO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5937548" y="1259071"/>
            <a:ext cx="6060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6585884" y="1259071"/>
            <a:ext cx="6060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5981362" y="148596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658913" y="150736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283750" y="129628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979332" y="128896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991847" y="1507365"/>
            <a:ext cx="231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673460" y="1288961"/>
            <a:ext cx="231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304626" y="1500409"/>
            <a:ext cx="231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980592" y="1269643"/>
            <a:ext cx="231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7278367" y="3427953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β-actin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262336" y="1875023"/>
            <a:ext cx="817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β-catenin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5678059" y="1935978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322697" y="178726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413679" y="341049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46</a:t>
            </a:r>
          </a:p>
        </p:txBody>
      </p:sp>
      <p:cxnSp>
        <p:nvCxnSpPr>
          <p:cNvPr id="23" name="Straight Connector 22"/>
          <p:cNvCxnSpPr/>
          <p:nvPr/>
        </p:nvCxnSpPr>
        <p:spPr>
          <a:xfrm>
            <a:off x="5711691" y="3509668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5383483" y="1538862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kD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263486" y="2385488"/>
            <a:ext cx="9669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N-Cadherin</a:t>
            </a:r>
          </a:p>
        </p:txBody>
      </p:sp>
      <p:cxnSp>
        <p:nvCxnSpPr>
          <p:cNvPr id="29" name="Straight Connector 28"/>
          <p:cNvCxnSpPr/>
          <p:nvPr/>
        </p:nvCxnSpPr>
        <p:spPr>
          <a:xfrm>
            <a:off x="5694055" y="2623763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5322697" y="248419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13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303121" y="2909384"/>
            <a:ext cx="778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Vimentin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5694055" y="3090368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5322697" y="295080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55</a:t>
            </a: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2"/>
          <a:srcRect t="18684" b="27597"/>
          <a:stretch/>
        </p:blipFill>
        <p:spPr>
          <a:xfrm>
            <a:off x="5858732" y="3330441"/>
            <a:ext cx="1427889" cy="4720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3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23151" t="5692"/>
          <a:stretch/>
        </p:blipFill>
        <p:spPr>
          <a:xfrm rot="5400000">
            <a:off x="6325569" y="2346566"/>
            <a:ext cx="478184" cy="13953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5"/>
          <a:srcRect t="20227" b="20227"/>
          <a:stretch/>
        </p:blipFill>
        <p:spPr>
          <a:xfrm>
            <a:off x="5859798" y="2289933"/>
            <a:ext cx="1412096" cy="4781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TextBox 37"/>
          <p:cNvSpPr txBox="1"/>
          <p:nvPr/>
        </p:nvSpPr>
        <p:spPr>
          <a:xfrm>
            <a:off x="302890" y="97321"/>
            <a:ext cx="118157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4: SSc fibroblasts trigger EMT in lung epithelial cells through HOTAIR/EZH2/Wnt3a/β-Catenin signalling</a:t>
            </a: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17997" b="12466"/>
          <a:stretch/>
        </p:blipFill>
        <p:spPr>
          <a:xfrm>
            <a:off x="5860245" y="1776191"/>
            <a:ext cx="1411649" cy="4692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0" name="TextBox 39"/>
          <p:cNvSpPr txBox="1"/>
          <p:nvPr/>
        </p:nvSpPr>
        <p:spPr>
          <a:xfrm>
            <a:off x="2218300" y="1218109"/>
            <a:ext cx="7602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cramble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917871" y="1239759"/>
            <a:ext cx="6544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OTAIR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561726" y="1526612"/>
            <a:ext cx="9620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QB (20µM)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569679" y="1771166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MSO</a:t>
            </a:r>
          </a:p>
        </p:txBody>
      </p:sp>
      <p:cxnSp>
        <p:nvCxnSpPr>
          <p:cNvPr id="44" name="Straight Connector 43"/>
          <p:cNvCxnSpPr/>
          <p:nvPr/>
        </p:nvCxnSpPr>
        <p:spPr>
          <a:xfrm>
            <a:off x="2235333" y="1491492"/>
            <a:ext cx="6060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2883669" y="1491492"/>
            <a:ext cx="6060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2279147" y="171839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956698" y="173978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2581535" y="152870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277117" y="152138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3289632" y="1739786"/>
            <a:ext cx="231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971245" y="1521382"/>
            <a:ext cx="231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602411" y="1732830"/>
            <a:ext cx="231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2278377" y="1502064"/>
            <a:ext cx="231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545052" y="3107785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β-actin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560121" y="2107444"/>
            <a:ext cx="817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β-catenin</a:t>
            </a:r>
          </a:p>
        </p:txBody>
      </p:sp>
      <p:cxnSp>
        <p:nvCxnSpPr>
          <p:cNvPr id="56" name="Straight Connector 55"/>
          <p:cNvCxnSpPr/>
          <p:nvPr/>
        </p:nvCxnSpPr>
        <p:spPr>
          <a:xfrm>
            <a:off x="1975844" y="2168399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1620482" y="201968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680364" y="309032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46</a:t>
            </a:r>
          </a:p>
        </p:txBody>
      </p:sp>
      <p:cxnSp>
        <p:nvCxnSpPr>
          <p:cNvPr id="59" name="Straight Connector 58"/>
          <p:cNvCxnSpPr/>
          <p:nvPr/>
        </p:nvCxnSpPr>
        <p:spPr>
          <a:xfrm>
            <a:off x="1978376" y="3189500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1681268" y="1771283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kDa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3561271" y="2617909"/>
            <a:ext cx="9669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N-Cadherin</a:t>
            </a:r>
          </a:p>
        </p:txBody>
      </p:sp>
      <p:cxnSp>
        <p:nvCxnSpPr>
          <p:cNvPr id="62" name="Straight Connector 61"/>
          <p:cNvCxnSpPr/>
          <p:nvPr/>
        </p:nvCxnSpPr>
        <p:spPr>
          <a:xfrm>
            <a:off x="1991840" y="2856184"/>
            <a:ext cx="1552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1620482" y="271661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130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8"/>
          <a:srcRect l="15263" r="14552"/>
          <a:stretch/>
        </p:blipFill>
        <p:spPr>
          <a:xfrm rot="5400000">
            <a:off x="2619647" y="2567077"/>
            <a:ext cx="472021" cy="14131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t="10239" b="12663"/>
          <a:stretch/>
        </p:blipFill>
        <p:spPr>
          <a:xfrm>
            <a:off x="2154138" y="1987218"/>
            <a:ext cx="1453771" cy="46623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67" name="Chart 66"/>
          <p:cNvGraphicFramePr>
            <a:graphicFrameLocks/>
          </p:cNvGraphicFramePr>
          <p:nvPr/>
        </p:nvGraphicFramePr>
        <p:xfrm>
          <a:off x="8346104" y="1942358"/>
          <a:ext cx="2362604" cy="18881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68" name="TextBox 67"/>
          <p:cNvSpPr txBox="1"/>
          <p:nvPr/>
        </p:nvSpPr>
        <p:spPr>
          <a:xfrm rot="16200000">
            <a:off x="7204939" y="2526044"/>
            <a:ext cx="20406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lative  N-CAD protein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evels</a:t>
            </a:r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t="23114" b="21270"/>
          <a:stretch/>
        </p:blipFill>
        <p:spPr>
          <a:xfrm>
            <a:off x="2153307" y="2508895"/>
            <a:ext cx="1447599" cy="4671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7" name="TextBox 96"/>
          <p:cNvSpPr txBox="1"/>
          <p:nvPr/>
        </p:nvSpPr>
        <p:spPr>
          <a:xfrm>
            <a:off x="1362648" y="89750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5109588" y="84035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8BBAA99F-FA8A-D1C8-ED96-B00184131F1D}"/>
              </a:ext>
            </a:extLst>
          </p:cNvPr>
          <p:cNvCxnSpPr/>
          <p:nvPr/>
        </p:nvCxnSpPr>
        <p:spPr>
          <a:xfrm>
            <a:off x="9897029" y="2148039"/>
            <a:ext cx="4804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F06D2C64-0D76-348D-0DBA-CE4C7E9B23E9}"/>
              </a:ext>
            </a:extLst>
          </p:cNvPr>
          <p:cNvSpPr txBox="1"/>
          <p:nvPr/>
        </p:nvSpPr>
        <p:spPr>
          <a:xfrm>
            <a:off x="9962587" y="190443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*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7C6675B2-3375-7BB2-F819-E6464B6DE379}"/>
              </a:ext>
            </a:extLst>
          </p:cNvPr>
          <p:cNvCxnSpPr/>
          <p:nvPr/>
        </p:nvCxnSpPr>
        <p:spPr>
          <a:xfrm>
            <a:off x="8927039" y="2148039"/>
            <a:ext cx="851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EF0BE23C-E0F6-202A-B8EA-14C552D02EC1}"/>
              </a:ext>
            </a:extLst>
          </p:cNvPr>
          <p:cNvSpPr txBox="1"/>
          <p:nvPr/>
        </p:nvSpPr>
        <p:spPr>
          <a:xfrm>
            <a:off x="9204599" y="189485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41897105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94</Words>
  <Application>Microsoft Office PowerPoint</Application>
  <PresentationFormat>Widescreen</PresentationFormat>
  <Paragraphs>11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1_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ristopher Wasson</dc:creator>
  <cp:lastModifiedBy>Christopher Wasson</cp:lastModifiedBy>
  <cp:revision>1</cp:revision>
  <dcterms:created xsi:type="dcterms:W3CDTF">2026-06-05T14:21:41Z</dcterms:created>
  <dcterms:modified xsi:type="dcterms:W3CDTF">2026-06-05T14:23:20Z</dcterms:modified>
</cp:coreProperties>
</file>